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NDB&#12458;&#12540;&#12503;&#12531;&#12487;&#12540;&#12479;&#12398;&#20998;&#26512;\&#21407;&#31295;_%20&#21307;&#30274;&#36027;&#35036;&#21161;&#25919;&#31574;&#12392;&#12501;&#12483;&#21270;&#29289;&#27927;&#21475;\&#12464;&#12521;&#12501;&#20316;&#25104;&#29992;_bmcpb_revision_113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3288307346738072E-2"/>
          <c:y val="2.6100762861044544E-2"/>
          <c:w val="0.95368685072747983"/>
          <c:h val="0.843457749388121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政策!$F$1:$F$2</c:f>
              <c:strCache>
                <c:ptCount val="2"/>
                <c:pt idx="1">
                  <c:v>201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政策!$F$3:$F$49</c:f>
              <c:numCache>
                <c:formatCode>General</c:formatCode>
                <c:ptCount val="4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1</c:v>
                </c:pt>
                <c:pt idx="11">
                  <c:v>3</c:v>
                </c:pt>
                <c:pt idx="12">
                  <c:v>3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3</c:v>
                </c:pt>
                <c:pt idx="18">
                  <c:v>2</c:v>
                </c:pt>
                <c:pt idx="19">
                  <c:v>1</c:v>
                </c:pt>
                <c:pt idx="20">
                  <c:v>2</c:v>
                </c:pt>
                <c:pt idx="21">
                  <c:v>3</c:v>
                </c:pt>
                <c:pt idx="22">
                  <c:v>2</c:v>
                </c:pt>
                <c:pt idx="23">
                  <c:v>3</c:v>
                </c:pt>
                <c:pt idx="24">
                  <c:v>2</c:v>
                </c:pt>
                <c:pt idx="25">
                  <c:v>3</c:v>
                </c:pt>
                <c:pt idx="26">
                  <c:v>1</c:v>
                </c:pt>
                <c:pt idx="27">
                  <c:v>3</c:v>
                </c:pt>
                <c:pt idx="28">
                  <c:v>1</c:v>
                </c:pt>
                <c:pt idx="29">
                  <c:v>2</c:v>
                </c:pt>
                <c:pt idx="30">
                  <c:v>3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3</c:v>
                </c:pt>
                <c:pt idx="36">
                  <c:v>2</c:v>
                </c:pt>
                <c:pt idx="37">
                  <c:v>1</c:v>
                </c:pt>
                <c:pt idx="38">
                  <c:v>1</c:v>
                </c:pt>
                <c:pt idx="39">
                  <c:v>1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AD-40F8-99AD-A1BDFF98F317}"/>
            </c:ext>
          </c:extLst>
        </c:ser>
        <c:ser>
          <c:idx val="1"/>
          <c:order val="1"/>
          <c:tx>
            <c:strRef>
              <c:f>政策!$G$1:$G$2</c:f>
              <c:strCache>
                <c:ptCount val="2"/>
                <c:pt idx="1">
                  <c:v>2018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ja-JP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政策!$G$3:$G$49</c:f>
              <c:numCache>
                <c:formatCode>General</c:formatCode>
                <c:ptCount val="4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1</c:v>
                </c:pt>
                <c:pt idx="11">
                  <c:v>3</c:v>
                </c:pt>
                <c:pt idx="12">
                  <c:v>3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3</c:v>
                </c:pt>
                <c:pt idx="18">
                  <c:v>2</c:v>
                </c:pt>
                <c:pt idx="19">
                  <c:v>1</c:v>
                </c:pt>
                <c:pt idx="20">
                  <c:v>2</c:v>
                </c:pt>
                <c:pt idx="21">
                  <c:v>3</c:v>
                </c:pt>
                <c:pt idx="22">
                  <c:v>2</c:v>
                </c:pt>
                <c:pt idx="23">
                  <c:v>3</c:v>
                </c:pt>
                <c:pt idx="24">
                  <c:v>2</c:v>
                </c:pt>
                <c:pt idx="25">
                  <c:v>3</c:v>
                </c:pt>
                <c:pt idx="26">
                  <c:v>1</c:v>
                </c:pt>
                <c:pt idx="27">
                  <c:v>3</c:v>
                </c:pt>
                <c:pt idx="28">
                  <c:v>3</c:v>
                </c:pt>
                <c:pt idx="29">
                  <c:v>2</c:v>
                </c:pt>
                <c:pt idx="30">
                  <c:v>3</c:v>
                </c:pt>
                <c:pt idx="31">
                  <c:v>1</c:v>
                </c:pt>
                <c:pt idx="32">
                  <c:v>1</c:v>
                </c:pt>
                <c:pt idx="33">
                  <c:v>1</c:v>
                </c:pt>
                <c:pt idx="34">
                  <c:v>1</c:v>
                </c:pt>
                <c:pt idx="35">
                  <c:v>3</c:v>
                </c:pt>
                <c:pt idx="36">
                  <c:v>2</c:v>
                </c:pt>
                <c:pt idx="37">
                  <c:v>1</c:v>
                </c:pt>
                <c:pt idx="38">
                  <c:v>1</c:v>
                </c:pt>
                <c:pt idx="39">
                  <c:v>3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1</c:v>
                </c:pt>
                <c:pt idx="44">
                  <c:v>1</c:v>
                </c:pt>
                <c:pt idx="45">
                  <c:v>1</c:v>
                </c:pt>
                <c:pt idx="4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AD-40F8-99AD-A1BDFF98F31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669434591"/>
        <c:axId val="898508431"/>
      </c:barChart>
      <c:catAx>
        <c:axId val="6694345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98508431"/>
        <c:crosses val="autoZero"/>
        <c:auto val="1"/>
        <c:lblAlgn val="ctr"/>
        <c:lblOffset val="100"/>
        <c:noMultiLvlLbl val="0"/>
      </c:catAx>
      <c:valAx>
        <c:axId val="898508431"/>
        <c:scaling>
          <c:orientation val="minMax"/>
          <c:max val="3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69434591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6840643437278897"/>
          <c:y val="0.24809276748279827"/>
          <c:w val="0.12346941208061903"/>
          <c:h val="6.995884050235202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43DC77-A271-59F5-D55A-34C37773D8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27E775-A75E-72C3-8B29-D00DB28C30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3334CE-66D1-01BC-0892-9FDC7756E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F20D4A-A2B7-4470-09C6-6E85CF6E8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D0B358-E515-6038-8FE4-CEE486746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9797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6F22B9-3D77-2A8E-3B09-6786753F0A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F10BF24-9BE9-32E4-7A83-A0DC2398BB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3299C77-A68E-BBA4-6FAE-7EB6DB5F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5E6ECA1-0675-CEA1-77A3-B6B183A1B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217A69-7625-BA8D-A570-B257F8D6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53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105D4B15-19F5-1B26-7E9A-BFCFB6EE43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776D627-F637-0A82-C18D-0CAA2B9F9B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212BFC-389F-91B6-5510-932A6B27A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AF69F6F-956E-B0C0-4E41-0B3D70EF4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C9DA32D-9D7A-7090-5B44-486932F20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360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4A640D-60D2-0DAB-326C-DAD962557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33413-7D16-8BD1-159F-5783A08AE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9B6378-0983-38D7-C3F3-391E54065C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4360BA4-C8B4-E86D-DDBA-C96EAF3CC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5B040C-451A-3FDC-9815-78C46D36C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74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812DA3-EAC7-0466-D0A7-74726EDDDA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8063543-00C5-F06C-F901-5F4736FF8D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C0C0D54-E11D-2100-1082-390CCB3A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928D9F-4A3F-A193-0356-3A7FFD0CC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58EDF2B-B3F8-7088-D440-177F6F003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33543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BE370C3-7288-E156-4CDA-CD12C7B7C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39AC83A-CCD3-CF9B-0842-9FA65EA0DD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02069E7-CE31-B14E-8F15-725348EE9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3FF16AE-8A3E-46D7-ACD5-60223AAA50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60D6DD9-DFA9-DB84-AD1D-6D81E16B2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B0F7F54-6ABD-98FB-EBEE-BBAB12978F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184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470DA7C-2594-6C9F-015A-D96E96EA4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307476A-37D1-F63A-B228-1803DD9C1D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329D0D-3C75-C050-9AA8-046501921D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3396B8A3-F18B-FA21-3E7F-55B7CE264E4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95F0172-07E9-1BD1-4BE6-274DF4C468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EA39993C-D8A7-86A7-419D-8CC9B9B90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C920688-ABFA-3F8E-4ECA-27A58870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B328E0D-17D3-AA06-0F66-9FA3D9AB3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512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E4B0CF-A5B3-0B82-2CEC-39CDF30623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65D74F-64C2-A671-482B-553D8D371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C484A4E-E892-278F-9ABA-B3B7D642E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D527508-3A04-46BC-638E-1CF59DEB1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262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D4C87BA-3A7F-83B6-2763-7F44FCED2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EBF0517-E863-0C9E-AD5A-97E1DEB50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8E4E00F-1C47-9276-6B92-1112BD169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990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253E4-B1B1-3DB8-F98E-67A83577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3D5132-A9BE-D52F-5E9A-44869C6CFA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7E9A37D-6D13-4556-5993-EFD57CF2A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0E6028F-C45A-C768-F3DF-1A3EBCE3A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C257CB5-2ED2-E0FF-A6D9-11B1DEE2C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816789D-CD1A-4DE9-5261-9B76E5A47E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54505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DCE48B-160C-A889-6685-7D50FCE3F8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D3D4F2-8379-7544-D556-9158BA6C16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EBE937E-A323-8E2F-91B8-6B6A2197C12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4343373-95E2-E9CA-DE03-BDF23F65BD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0194E29-7F03-0BF8-973F-56C22C696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16E4EE-F028-D2C6-7702-24616E674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76976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BE57FFD-B15E-6F48-E2AA-38710242D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D1A6F5-FCEB-53E1-DA29-F7D97EA11E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3D23F2-F598-4B43-7FAD-03E8CE714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9748C-8CA8-4318-9C23-65AF0C021C86}" type="datetimeFigureOut">
              <a:rPr kumimoji="1" lang="ja-JP" altLang="en-US" smtClean="0"/>
              <a:t>2024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3A2A1F-FDBB-B79D-0684-734F8655BF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2495D6E-2C5B-2860-08A9-652075FE37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9D7D9-E9F8-4FFF-BCD4-4470C51BB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1740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F7B022F0-4171-CE36-E46F-1AC16EE7AB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18110353"/>
              </p:ext>
            </p:extLst>
          </p:nvPr>
        </p:nvGraphicFramePr>
        <p:xfrm>
          <a:off x="928459" y="18488"/>
          <a:ext cx="10725658" cy="58774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99B19F2-F3B1-CEB0-6187-15ED5938999A}"/>
              </a:ext>
            </a:extLst>
          </p:cNvPr>
          <p:cNvSpPr txBox="1"/>
          <p:nvPr/>
        </p:nvSpPr>
        <p:spPr>
          <a:xfrm>
            <a:off x="5444218" y="5462768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fectur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7574BA-4672-24CA-AB1A-665E5CA6DE09}"/>
              </a:ext>
            </a:extLst>
          </p:cNvPr>
          <p:cNvSpPr txBox="1"/>
          <p:nvPr/>
        </p:nvSpPr>
        <p:spPr>
          <a:xfrm>
            <a:off x="0" y="2653010"/>
            <a:ext cx="92845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idy</a:t>
            </a:r>
          </a:p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licy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ter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C626B82-7E29-9027-9B9E-8D11DC04ED1F}"/>
              </a:ext>
            </a:extLst>
          </p:cNvPr>
          <p:cNvSpPr txBox="1"/>
          <p:nvPr/>
        </p:nvSpPr>
        <p:spPr>
          <a:xfrm>
            <a:off x="268940" y="5650563"/>
            <a:ext cx="1168100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3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 1. </a:t>
            </a:r>
            <a:r>
              <a:rPr lang="en-US" altLang="ja-JP" sz="13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Ｐゴシック" panose="020B0600070205080204" pitchFamily="50" charset="-128"/>
              </a:rPr>
              <a:t>Co-payment until children enters elementary school, 2. No co-payment until children enters elementary school, 3. Co-payment continuing beyond elementary school</a:t>
            </a:r>
            <a:endParaRPr kumimoji="1" lang="ja-JP" altLang="en-US" sz="13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8658F899-0346-9515-6829-146895770F06}"/>
              </a:ext>
            </a:extLst>
          </p:cNvPr>
          <p:cNvCxnSpPr>
            <a:cxnSpLocks/>
          </p:cNvCxnSpPr>
          <p:nvPr/>
        </p:nvCxnSpPr>
        <p:spPr>
          <a:xfrm>
            <a:off x="1140643" y="0"/>
            <a:ext cx="0" cy="51412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1F29BD4-679D-E722-7FDD-DF77F33061D1}"/>
              </a:ext>
            </a:extLst>
          </p:cNvPr>
          <p:cNvCxnSpPr>
            <a:cxnSpLocks/>
          </p:cNvCxnSpPr>
          <p:nvPr/>
        </p:nvCxnSpPr>
        <p:spPr>
          <a:xfrm flipH="1">
            <a:off x="1140643" y="5133574"/>
            <a:ext cx="1067973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EAC4341-0D5E-CDA7-3D41-D715792131CD}"/>
              </a:ext>
            </a:extLst>
          </p:cNvPr>
          <p:cNvSpPr txBox="1"/>
          <p:nvPr/>
        </p:nvSpPr>
        <p:spPr>
          <a:xfrm>
            <a:off x="331695" y="6204075"/>
            <a:ext cx="1151481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The subsidy policy pattern trend among prefectures in Japan between 2016 to 2018</a:t>
            </a:r>
            <a:endParaRPr lang="ja-JP" altLang="en-US" sz="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gends: A figure shows the subsidy policy pattern trends in each prefecture between 2016 and 2018.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222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7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貴文</dc:creator>
  <cp:lastModifiedBy>takafumi yamamoto</cp:lastModifiedBy>
  <cp:revision>7</cp:revision>
  <dcterms:created xsi:type="dcterms:W3CDTF">2023-12-07T06:34:18Z</dcterms:created>
  <dcterms:modified xsi:type="dcterms:W3CDTF">2024-02-12T23:18:45Z</dcterms:modified>
</cp:coreProperties>
</file>